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90" d="100"/>
          <a:sy n="90" d="100"/>
        </p:scale>
        <p:origin x="39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961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611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4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87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129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504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397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078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780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18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6768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53052-CE13-460D-8FB4-7AEA807EA9FB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70733-0A37-4CC3-815D-82B8F58F63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846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678770" y="432360"/>
            <a:ext cx="9869763" cy="5839391"/>
            <a:chOff x="1678770" y="432360"/>
            <a:chExt cx="9869763" cy="583939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8530" y="805270"/>
              <a:ext cx="8394192" cy="500481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1678770" y="432360"/>
              <a:ext cx="986976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2 </a:t>
              </a:r>
              <a:r>
                <a:rPr lang="en-GB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Boxplots </a:t>
              </a:r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ing the differences in 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il physicochemical properties (</a:t>
              </a:r>
              <a:r>
                <a:rPr lang="en-GB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n, N, Na, P, pH, Sand and Silt</a:t>
              </a:r>
              <a:r>
                <a:rPr lang="en-GB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898530" y="5810086"/>
              <a:ext cx="89197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S2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: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fferences between soil physiochemical properties of samples </a:t>
              </a:r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lected from the selected ecoregions in Kenya. The boxplots indicate differences in Mn, N, Na, P, pH, Sand and Silt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68235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6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</dc:creator>
  <cp:lastModifiedBy>Anne</cp:lastModifiedBy>
  <cp:revision>19</cp:revision>
  <dcterms:created xsi:type="dcterms:W3CDTF">2022-12-12T13:17:02Z</dcterms:created>
  <dcterms:modified xsi:type="dcterms:W3CDTF">2023-04-17T09:33:09Z</dcterms:modified>
</cp:coreProperties>
</file>